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5792450" cy="104584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799" autoAdjust="0"/>
    <p:restoredTop sz="94660"/>
  </p:normalViewPr>
  <p:slideViewPr>
    <p:cSldViewPr snapToGrid="0">
      <p:cViewPr varScale="1">
        <p:scale>
          <a:sx n="92" d="100"/>
          <a:sy n="92" d="100"/>
        </p:scale>
        <p:origin x="144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84434" y="1711604"/>
            <a:ext cx="13423583" cy="3641090"/>
          </a:xfrm>
        </p:spPr>
        <p:txBody>
          <a:bodyPr anchor="b"/>
          <a:lstStyle>
            <a:lvl1pPr algn="ctr">
              <a:defRPr sz="915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74056" y="5493108"/>
            <a:ext cx="11844338" cy="2525037"/>
          </a:xfrm>
        </p:spPr>
        <p:txBody>
          <a:bodyPr/>
          <a:lstStyle>
            <a:lvl1pPr marL="0" indent="0" algn="ctr">
              <a:buNone/>
              <a:defRPr sz="3660"/>
            </a:lvl1pPr>
            <a:lvl2pPr marL="697230" indent="0" algn="ctr">
              <a:buNone/>
              <a:defRPr sz="3050"/>
            </a:lvl2pPr>
            <a:lvl3pPr marL="1394460" indent="0" algn="ctr">
              <a:buNone/>
              <a:defRPr sz="2745"/>
            </a:lvl3pPr>
            <a:lvl4pPr marL="2091690" indent="0" algn="ctr">
              <a:buNone/>
              <a:defRPr sz="2440"/>
            </a:lvl4pPr>
            <a:lvl5pPr marL="2788920" indent="0" algn="ctr">
              <a:buNone/>
              <a:defRPr sz="2440"/>
            </a:lvl5pPr>
            <a:lvl6pPr marL="3486150" indent="0" algn="ctr">
              <a:buNone/>
              <a:defRPr sz="2440"/>
            </a:lvl6pPr>
            <a:lvl7pPr marL="4183380" indent="0" algn="ctr">
              <a:buNone/>
              <a:defRPr sz="2440"/>
            </a:lvl7pPr>
            <a:lvl8pPr marL="4880610" indent="0" algn="ctr">
              <a:buNone/>
              <a:defRPr sz="2440"/>
            </a:lvl8pPr>
            <a:lvl9pPr marL="5577840" indent="0" algn="ctr">
              <a:buNone/>
              <a:defRPr sz="244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4BB8E-78F6-4FBD-A765-5193C8B4F39C}" type="datetimeFigureOut">
              <a:rPr lang="en-US" smtClean="0"/>
              <a:t>1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5C372-A204-499B-A2B2-EAE987E5E6E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5317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4BB8E-78F6-4FBD-A765-5193C8B4F39C}" type="datetimeFigureOut">
              <a:rPr lang="en-US" smtClean="0"/>
              <a:t>1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5C372-A204-499B-A2B2-EAE987E5E6E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2766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301473" y="556816"/>
            <a:ext cx="3405247" cy="8863053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85732" y="556816"/>
            <a:ext cx="10018335" cy="8863053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4BB8E-78F6-4FBD-A765-5193C8B4F39C}" type="datetimeFigureOut">
              <a:rPr lang="en-US" smtClean="0"/>
              <a:t>1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5C372-A204-499B-A2B2-EAE987E5E6E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93531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4BB8E-78F6-4FBD-A765-5193C8B4F39C}" type="datetimeFigureOut">
              <a:rPr lang="en-US" smtClean="0"/>
              <a:t>1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5C372-A204-499B-A2B2-EAE987E5E6E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3852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7507" y="2607353"/>
            <a:ext cx="13620988" cy="4350424"/>
          </a:xfrm>
        </p:spPr>
        <p:txBody>
          <a:bodyPr anchor="b"/>
          <a:lstStyle>
            <a:lvl1pPr>
              <a:defRPr sz="915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77507" y="6998933"/>
            <a:ext cx="13620988" cy="2287785"/>
          </a:xfrm>
        </p:spPr>
        <p:txBody>
          <a:bodyPr/>
          <a:lstStyle>
            <a:lvl1pPr marL="0" indent="0">
              <a:buNone/>
              <a:defRPr sz="3660">
                <a:solidFill>
                  <a:schemeClr val="tx1"/>
                </a:solidFill>
              </a:defRPr>
            </a:lvl1pPr>
            <a:lvl2pPr marL="697230" indent="0">
              <a:buNone/>
              <a:defRPr sz="3050">
                <a:solidFill>
                  <a:schemeClr val="tx1">
                    <a:tint val="75000"/>
                  </a:schemeClr>
                </a:solidFill>
              </a:defRPr>
            </a:lvl2pPr>
            <a:lvl3pPr marL="1394460" indent="0">
              <a:buNone/>
              <a:defRPr sz="2745">
                <a:solidFill>
                  <a:schemeClr val="tx1">
                    <a:tint val="75000"/>
                  </a:schemeClr>
                </a:solidFill>
              </a:defRPr>
            </a:lvl3pPr>
            <a:lvl4pPr marL="2091690" indent="0">
              <a:buNone/>
              <a:defRPr sz="2440">
                <a:solidFill>
                  <a:schemeClr val="tx1">
                    <a:tint val="75000"/>
                  </a:schemeClr>
                </a:solidFill>
              </a:defRPr>
            </a:lvl4pPr>
            <a:lvl5pPr marL="2788920" indent="0">
              <a:buNone/>
              <a:defRPr sz="2440">
                <a:solidFill>
                  <a:schemeClr val="tx1">
                    <a:tint val="75000"/>
                  </a:schemeClr>
                </a:solidFill>
              </a:defRPr>
            </a:lvl5pPr>
            <a:lvl6pPr marL="3486150" indent="0">
              <a:buNone/>
              <a:defRPr sz="2440">
                <a:solidFill>
                  <a:schemeClr val="tx1">
                    <a:tint val="75000"/>
                  </a:schemeClr>
                </a:solidFill>
              </a:defRPr>
            </a:lvl6pPr>
            <a:lvl7pPr marL="4183380" indent="0">
              <a:buNone/>
              <a:defRPr sz="2440">
                <a:solidFill>
                  <a:schemeClr val="tx1">
                    <a:tint val="75000"/>
                  </a:schemeClr>
                </a:solidFill>
              </a:defRPr>
            </a:lvl7pPr>
            <a:lvl8pPr marL="4880610" indent="0">
              <a:buNone/>
              <a:defRPr sz="2440">
                <a:solidFill>
                  <a:schemeClr val="tx1">
                    <a:tint val="75000"/>
                  </a:schemeClr>
                </a:solidFill>
              </a:defRPr>
            </a:lvl8pPr>
            <a:lvl9pPr marL="5577840" indent="0">
              <a:buNone/>
              <a:defRPr sz="24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4BB8E-78F6-4FBD-A765-5193C8B4F39C}" type="datetimeFigureOut">
              <a:rPr lang="en-US" smtClean="0"/>
              <a:t>1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5C372-A204-499B-A2B2-EAE987E5E6E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63481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85731" y="2784078"/>
            <a:ext cx="6711791" cy="6635790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994928" y="2784078"/>
            <a:ext cx="6711791" cy="6635790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4BB8E-78F6-4FBD-A765-5193C8B4F39C}" type="datetimeFigureOut">
              <a:rPr lang="en-US" smtClean="0"/>
              <a:t>1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5C372-A204-499B-A2B2-EAE987E5E6E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60506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87788" y="556818"/>
            <a:ext cx="13620988" cy="2021484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87789" y="2563773"/>
            <a:ext cx="6680946" cy="1256466"/>
          </a:xfrm>
        </p:spPr>
        <p:txBody>
          <a:bodyPr anchor="b"/>
          <a:lstStyle>
            <a:lvl1pPr marL="0" indent="0">
              <a:buNone/>
              <a:defRPr sz="3660" b="1"/>
            </a:lvl1pPr>
            <a:lvl2pPr marL="697230" indent="0">
              <a:buNone/>
              <a:defRPr sz="3050" b="1"/>
            </a:lvl2pPr>
            <a:lvl3pPr marL="1394460" indent="0">
              <a:buNone/>
              <a:defRPr sz="2745" b="1"/>
            </a:lvl3pPr>
            <a:lvl4pPr marL="2091690" indent="0">
              <a:buNone/>
              <a:defRPr sz="2440" b="1"/>
            </a:lvl4pPr>
            <a:lvl5pPr marL="2788920" indent="0">
              <a:buNone/>
              <a:defRPr sz="2440" b="1"/>
            </a:lvl5pPr>
            <a:lvl6pPr marL="3486150" indent="0">
              <a:buNone/>
              <a:defRPr sz="2440" b="1"/>
            </a:lvl6pPr>
            <a:lvl7pPr marL="4183380" indent="0">
              <a:buNone/>
              <a:defRPr sz="2440" b="1"/>
            </a:lvl7pPr>
            <a:lvl8pPr marL="4880610" indent="0">
              <a:buNone/>
              <a:defRPr sz="2440" b="1"/>
            </a:lvl8pPr>
            <a:lvl9pPr marL="5577840" indent="0">
              <a:buNone/>
              <a:defRPr sz="244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87789" y="3820239"/>
            <a:ext cx="6680946" cy="5618997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994929" y="2563773"/>
            <a:ext cx="6713848" cy="1256466"/>
          </a:xfrm>
        </p:spPr>
        <p:txBody>
          <a:bodyPr anchor="b"/>
          <a:lstStyle>
            <a:lvl1pPr marL="0" indent="0">
              <a:buNone/>
              <a:defRPr sz="3660" b="1"/>
            </a:lvl1pPr>
            <a:lvl2pPr marL="697230" indent="0">
              <a:buNone/>
              <a:defRPr sz="3050" b="1"/>
            </a:lvl2pPr>
            <a:lvl3pPr marL="1394460" indent="0">
              <a:buNone/>
              <a:defRPr sz="2745" b="1"/>
            </a:lvl3pPr>
            <a:lvl4pPr marL="2091690" indent="0">
              <a:buNone/>
              <a:defRPr sz="2440" b="1"/>
            </a:lvl4pPr>
            <a:lvl5pPr marL="2788920" indent="0">
              <a:buNone/>
              <a:defRPr sz="2440" b="1"/>
            </a:lvl5pPr>
            <a:lvl6pPr marL="3486150" indent="0">
              <a:buNone/>
              <a:defRPr sz="2440" b="1"/>
            </a:lvl6pPr>
            <a:lvl7pPr marL="4183380" indent="0">
              <a:buNone/>
              <a:defRPr sz="2440" b="1"/>
            </a:lvl7pPr>
            <a:lvl8pPr marL="4880610" indent="0">
              <a:buNone/>
              <a:defRPr sz="2440" b="1"/>
            </a:lvl8pPr>
            <a:lvl9pPr marL="5577840" indent="0">
              <a:buNone/>
              <a:defRPr sz="244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994929" y="3820239"/>
            <a:ext cx="6713848" cy="5618997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4BB8E-78F6-4FBD-A765-5193C8B4F39C}" type="datetimeFigureOut">
              <a:rPr lang="en-US" smtClean="0"/>
              <a:t>1/10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5C372-A204-499B-A2B2-EAE987E5E6E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63883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4BB8E-78F6-4FBD-A765-5193C8B4F39C}" type="datetimeFigureOut">
              <a:rPr lang="en-US" smtClean="0"/>
              <a:t>1/10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5C372-A204-499B-A2B2-EAE987E5E6E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6509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4BB8E-78F6-4FBD-A765-5193C8B4F39C}" type="datetimeFigureOut">
              <a:rPr lang="en-US" smtClean="0"/>
              <a:t>1/10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5C372-A204-499B-A2B2-EAE987E5E6E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0595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87788" y="697230"/>
            <a:ext cx="5093476" cy="2440305"/>
          </a:xfrm>
        </p:spPr>
        <p:txBody>
          <a:bodyPr anchor="b"/>
          <a:lstStyle>
            <a:lvl1pPr>
              <a:defRPr sz="488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713848" y="1505825"/>
            <a:ext cx="7994928" cy="7432278"/>
          </a:xfrm>
        </p:spPr>
        <p:txBody>
          <a:bodyPr/>
          <a:lstStyle>
            <a:lvl1pPr>
              <a:defRPr sz="4880"/>
            </a:lvl1pPr>
            <a:lvl2pPr>
              <a:defRPr sz="4270"/>
            </a:lvl2pPr>
            <a:lvl3pPr>
              <a:defRPr sz="3660"/>
            </a:lvl3pPr>
            <a:lvl4pPr>
              <a:defRPr sz="3050"/>
            </a:lvl4pPr>
            <a:lvl5pPr>
              <a:defRPr sz="3050"/>
            </a:lvl5pPr>
            <a:lvl6pPr>
              <a:defRPr sz="3050"/>
            </a:lvl6pPr>
            <a:lvl7pPr>
              <a:defRPr sz="3050"/>
            </a:lvl7pPr>
            <a:lvl8pPr>
              <a:defRPr sz="3050"/>
            </a:lvl8pPr>
            <a:lvl9pPr>
              <a:defRPr sz="305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87788" y="3137535"/>
            <a:ext cx="5093476" cy="5812672"/>
          </a:xfrm>
        </p:spPr>
        <p:txBody>
          <a:bodyPr/>
          <a:lstStyle>
            <a:lvl1pPr marL="0" indent="0">
              <a:buNone/>
              <a:defRPr sz="2440"/>
            </a:lvl1pPr>
            <a:lvl2pPr marL="697230" indent="0">
              <a:buNone/>
              <a:defRPr sz="2135"/>
            </a:lvl2pPr>
            <a:lvl3pPr marL="1394460" indent="0">
              <a:buNone/>
              <a:defRPr sz="1830"/>
            </a:lvl3pPr>
            <a:lvl4pPr marL="2091690" indent="0">
              <a:buNone/>
              <a:defRPr sz="1525"/>
            </a:lvl4pPr>
            <a:lvl5pPr marL="2788920" indent="0">
              <a:buNone/>
              <a:defRPr sz="1525"/>
            </a:lvl5pPr>
            <a:lvl6pPr marL="3486150" indent="0">
              <a:buNone/>
              <a:defRPr sz="1525"/>
            </a:lvl6pPr>
            <a:lvl7pPr marL="4183380" indent="0">
              <a:buNone/>
              <a:defRPr sz="1525"/>
            </a:lvl7pPr>
            <a:lvl8pPr marL="4880610" indent="0">
              <a:buNone/>
              <a:defRPr sz="1525"/>
            </a:lvl8pPr>
            <a:lvl9pPr marL="5577840" indent="0">
              <a:buNone/>
              <a:defRPr sz="1525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4BB8E-78F6-4FBD-A765-5193C8B4F39C}" type="datetimeFigureOut">
              <a:rPr lang="en-US" smtClean="0"/>
              <a:t>1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5C372-A204-499B-A2B2-EAE987E5E6E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7753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87788" y="697230"/>
            <a:ext cx="5093476" cy="2440305"/>
          </a:xfrm>
        </p:spPr>
        <p:txBody>
          <a:bodyPr anchor="b"/>
          <a:lstStyle>
            <a:lvl1pPr>
              <a:defRPr sz="488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713848" y="1505825"/>
            <a:ext cx="7994928" cy="7432278"/>
          </a:xfrm>
        </p:spPr>
        <p:txBody>
          <a:bodyPr anchor="t"/>
          <a:lstStyle>
            <a:lvl1pPr marL="0" indent="0">
              <a:buNone/>
              <a:defRPr sz="4880"/>
            </a:lvl1pPr>
            <a:lvl2pPr marL="697230" indent="0">
              <a:buNone/>
              <a:defRPr sz="4270"/>
            </a:lvl2pPr>
            <a:lvl3pPr marL="1394460" indent="0">
              <a:buNone/>
              <a:defRPr sz="3660"/>
            </a:lvl3pPr>
            <a:lvl4pPr marL="2091690" indent="0">
              <a:buNone/>
              <a:defRPr sz="3050"/>
            </a:lvl4pPr>
            <a:lvl5pPr marL="2788920" indent="0">
              <a:buNone/>
              <a:defRPr sz="3050"/>
            </a:lvl5pPr>
            <a:lvl6pPr marL="3486150" indent="0">
              <a:buNone/>
              <a:defRPr sz="3050"/>
            </a:lvl6pPr>
            <a:lvl7pPr marL="4183380" indent="0">
              <a:buNone/>
              <a:defRPr sz="3050"/>
            </a:lvl7pPr>
            <a:lvl8pPr marL="4880610" indent="0">
              <a:buNone/>
              <a:defRPr sz="3050"/>
            </a:lvl8pPr>
            <a:lvl9pPr marL="5577840" indent="0">
              <a:buNone/>
              <a:defRPr sz="305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87788" y="3137535"/>
            <a:ext cx="5093476" cy="5812672"/>
          </a:xfrm>
        </p:spPr>
        <p:txBody>
          <a:bodyPr/>
          <a:lstStyle>
            <a:lvl1pPr marL="0" indent="0">
              <a:buNone/>
              <a:defRPr sz="2440"/>
            </a:lvl1pPr>
            <a:lvl2pPr marL="697230" indent="0">
              <a:buNone/>
              <a:defRPr sz="2135"/>
            </a:lvl2pPr>
            <a:lvl3pPr marL="1394460" indent="0">
              <a:buNone/>
              <a:defRPr sz="1830"/>
            </a:lvl3pPr>
            <a:lvl4pPr marL="2091690" indent="0">
              <a:buNone/>
              <a:defRPr sz="1525"/>
            </a:lvl4pPr>
            <a:lvl5pPr marL="2788920" indent="0">
              <a:buNone/>
              <a:defRPr sz="1525"/>
            </a:lvl5pPr>
            <a:lvl6pPr marL="3486150" indent="0">
              <a:buNone/>
              <a:defRPr sz="1525"/>
            </a:lvl6pPr>
            <a:lvl7pPr marL="4183380" indent="0">
              <a:buNone/>
              <a:defRPr sz="1525"/>
            </a:lvl7pPr>
            <a:lvl8pPr marL="4880610" indent="0">
              <a:buNone/>
              <a:defRPr sz="1525"/>
            </a:lvl8pPr>
            <a:lvl9pPr marL="5577840" indent="0">
              <a:buNone/>
              <a:defRPr sz="1525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4BB8E-78F6-4FBD-A765-5193C8B4F39C}" type="datetimeFigureOut">
              <a:rPr lang="en-US" smtClean="0"/>
              <a:t>1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5C372-A204-499B-A2B2-EAE987E5E6E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45225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85731" y="556818"/>
            <a:ext cx="13620988" cy="20214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85731" y="2784078"/>
            <a:ext cx="13620988" cy="663579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85731" y="9693436"/>
            <a:ext cx="3553301" cy="5568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34BB8E-78F6-4FBD-A765-5193C8B4F39C}" type="datetimeFigureOut">
              <a:rPr lang="en-US" smtClean="0"/>
              <a:t>1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231249" y="9693436"/>
            <a:ext cx="5329952" cy="5568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153418" y="9693436"/>
            <a:ext cx="3553301" cy="5568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05C372-A204-499B-A2B2-EAE987E5E6E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269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394460" rtl="0" eaLnBrk="1" latinLnBrk="0" hangingPunct="1">
        <a:lnSpc>
          <a:spcPct val="90000"/>
        </a:lnSpc>
        <a:spcBef>
          <a:spcPct val="0"/>
        </a:spcBef>
        <a:buNone/>
        <a:defRPr sz="671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8615" indent="-348615" algn="l" defTabSz="1394460" rtl="0" eaLnBrk="1" latinLnBrk="0" hangingPunct="1">
        <a:lnSpc>
          <a:spcPct val="90000"/>
        </a:lnSpc>
        <a:spcBef>
          <a:spcPts val="1525"/>
        </a:spcBef>
        <a:buFont typeface="Arial" panose="020B0604020202020204" pitchFamily="34" charset="0"/>
        <a:buChar char="•"/>
        <a:defRPr sz="4270" kern="1200">
          <a:solidFill>
            <a:schemeClr val="tx1"/>
          </a:solidFill>
          <a:latin typeface="+mn-lt"/>
          <a:ea typeface="+mn-ea"/>
          <a:cs typeface="+mn-cs"/>
        </a:defRPr>
      </a:lvl1pPr>
      <a:lvl2pPr marL="1045845" indent="-348615" algn="l" defTabSz="1394460" rtl="0" eaLnBrk="1" latinLnBrk="0" hangingPunct="1">
        <a:lnSpc>
          <a:spcPct val="90000"/>
        </a:lnSpc>
        <a:spcBef>
          <a:spcPts val="763"/>
        </a:spcBef>
        <a:buFont typeface="Arial" panose="020B0604020202020204" pitchFamily="34" charset="0"/>
        <a:buChar char="•"/>
        <a:defRPr sz="3660" kern="1200">
          <a:solidFill>
            <a:schemeClr val="tx1"/>
          </a:solidFill>
          <a:latin typeface="+mn-lt"/>
          <a:ea typeface="+mn-ea"/>
          <a:cs typeface="+mn-cs"/>
        </a:defRPr>
      </a:lvl2pPr>
      <a:lvl3pPr marL="1743075" indent="-348615" algn="l" defTabSz="1394460" rtl="0" eaLnBrk="1" latinLnBrk="0" hangingPunct="1">
        <a:lnSpc>
          <a:spcPct val="90000"/>
        </a:lnSpc>
        <a:spcBef>
          <a:spcPts val="763"/>
        </a:spcBef>
        <a:buFont typeface="Arial" panose="020B0604020202020204" pitchFamily="34" charset="0"/>
        <a:buChar char="•"/>
        <a:defRPr sz="3050" kern="1200">
          <a:solidFill>
            <a:schemeClr val="tx1"/>
          </a:solidFill>
          <a:latin typeface="+mn-lt"/>
          <a:ea typeface="+mn-ea"/>
          <a:cs typeface="+mn-cs"/>
        </a:defRPr>
      </a:lvl3pPr>
      <a:lvl4pPr marL="2440305" indent="-348615" algn="l" defTabSz="1394460" rtl="0" eaLnBrk="1" latinLnBrk="0" hangingPunct="1">
        <a:lnSpc>
          <a:spcPct val="90000"/>
        </a:lnSpc>
        <a:spcBef>
          <a:spcPts val="763"/>
        </a:spcBef>
        <a:buFont typeface="Arial" panose="020B0604020202020204" pitchFamily="34" charset="0"/>
        <a:buChar char="•"/>
        <a:defRPr sz="2745" kern="1200">
          <a:solidFill>
            <a:schemeClr val="tx1"/>
          </a:solidFill>
          <a:latin typeface="+mn-lt"/>
          <a:ea typeface="+mn-ea"/>
          <a:cs typeface="+mn-cs"/>
        </a:defRPr>
      </a:lvl4pPr>
      <a:lvl5pPr marL="3137535" indent="-348615" algn="l" defTabSz="1394460" rtl="0" eaLnBrk="1" latinLnBrk="0" hangingPunct="1">
        <a:lnSpc>
          <a:spcPct val="90000"/>
        </a:lnSpc>
        <a:spcBef>
          <a:spcPts val="763"/>
        </a:spcBef>
        <a:buFont typeface="Arial" panose="020B0604020202020204" pitchFamily="34" charset="0"/>
        <a:buChar char="•"/>
        <a:defRPr sz="2745" kern="1200">
          <a:solidFill>
            <a:schemeClr val="tx1"/>
          </a:solidFill>
          <a:latin typeface="+mn-lt"/>
          <a:ea typeface="+mn-ea"/>
          <a:cs typeface="+mn-cs"/>
        </a:defRPr>
      </a:lvl5pPr>
      <a:lvl6pPr marL="3834765" indent="-348615" algn="l" defTabSz="1394460" rtl="0" eaLnBrk="1" latinLnBrk="0" hangingPunct="1">
        <a:lnSpc>
          <a:spcPct val="90000"/>
        </a:lnSpc>
        <a:spcBef>
          <a:spcPts val="763"/>
        </a:spcBef>
        <a:buFont typeface="Arial" panose="020B0604020202020204" pitchFamily="34" charset="0"/>
        <a:buChar char="•"/>
        <a:defRPr sz="2745" kern="1200">
          <a:solidFill>
            <a:schemeClr val="tx1"/>
          </a:solidFill>
          <a:latin typeface="+mn-lt"/>
          <a:ea typeface="+mn-ea"/>
          <a:cs typeface="+mn-cs"/>
        </a:defRPr>
      </a:lvl6pPr>
      <a:lvl7pPr marL="4531995" indent="-348615" algn="l" defTabSz="1394460" rtl="0" eaLnBrk="1" latinLnBrk="0" hangingPunct="1">
        <a:lnSpc>
          <a:spcPct val="90000"/>
        </a:lnSpc>
        <a:spcBef>
          <a:spcPts val="763"/>
        </a:spcBef>
        <a:buFont typeface="Arial" panose="020B0604020202020204" pitchFamily="34" charset="0"/>
        <a:buChar char="•"/>
        <a:defRPr sz="2745" kern="1200">
          <a:solidFill>
            <a:schemeClr val="tx1"/>
          </a:solidFill>
          <a:latin typeface="+mn-lt"/>
          <a:ea typeface="+mn-ea"/>
          <a:cs typeface="+mn-cs"/>
        </a:defRPr>
      </a:lvl7pPr>
      <a:lvl8pPr marL="5229225" indent="-348615" algn="l" defTabSz="1394460" rtl="0" eaLnBrk="1" latinLnBrk="0" hangingPunct="1">
        <a:lnSpc>
          <a:spcPct val="90000"/>
        </a:lnSpc>
        <a:spcBef>
          <a:spcPts val="763"/>
        </a:spcBef>
        <a:buFont typeface="Arial" panose="020B0604020202020204" pitchFamily="34" charset="0"/>
        <a:buChar char="•"/>
        <a:defRPr sz="2745" kern="1200">
          <a:solidFill>
            <a:schemeClr val="tx1"/>
          </a:solidFill>
          <a:latin typeface="+mn-lt"/>
          <a:ea typeface="+mn-ea"/>
          <a:cs typeface="+mn-cs"/>
        </a:defRPr>
      </a:lvl8pPr>
      <a:lvl9pPr marL="5926455" indent="-348615" algn="l" defTabSz="1394460" rtl="0" eaLnBrk="1" latinLnBrk="0" hangingPunct="1">
        <a:lnSpc>
          <a:spcPct val="90000"/>
        </a:lnSpc>
        <a:spcBef>
          <a:spcPts val="763"/>
        </a:spcBef>
        <a:buFont typeface="Arial" panose="020B0604020202020204" pitchFamily="34" charset="0"/>
        <a:buChar char="•"/>
        <a:defRPr sz="274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94460" rtl="0" eaLnBrk="1" latinLnBrk="0" hangingPunct="1">
        <a:defRPr sz="2745" kern="1200">
          <a:solidFill>
            <a:schemeClr val="tx1"/>
          </a:solidFill>
          <a:latin typeface="+mn-lt"/>
          <a:ea typeface="+mn-ea"/>
          <a:cs typeface="+mn-cs"/>
        </a:defRPr>
      </a:lvl1pPr>
      <a:lvl2pPr marL="697230" algn="l" defTabSz="1394460" rtl="0" eaLnBrk="1" latinLnBrk="0" hangingPunct="1">
        <a:defRPr sz="2745" kern="1200">
          <a:solidFill>
            <a:schemeClr val="tx1"/>
          </a:solidFill>
          <a:latin typeface="+mn-lt"/>
          <a:ea typeface="+mn-ea"/>
          <a:cs typeface="+mn-cs"/>
        </a:defRPr>
      </a:lvl2pPr>
      <a:lvl3pPr marL="1394460" algn="l" defTabSz="1394460" rtl="0" eaLnBrk="1" latinLnBrk="0" hangingPunct="1">
        <a:defRPr sz="2745" kern="1200">
          <a:solidFill>
            <a:schemeClr val="tx1"/>
          </a:solidFill>
          <a:latin typeface="+mn-lt"/>
          <a:ea typeface="+mn-ea"/>
          <a:cs typeface="+mn-cs"/>
        </a:defRPr>
      </a:lvl3pPr>
      <a:lvl4pPr marL="2091690" algn="l" defTabSz="1394460" rtl="0" eaLnBrk="1" latinLnBrk="0" hangingPunct="1">
        <a:defRPr sz="2745" kern="1200">
          <a:solidFill>
            <a:schemeClr val="tx1"/>
          </a:solidFill>
          <a:latin typeface="+mn-lt"/>
          <a:ea typeface="+mn-ea"/>
          <a:cs typeface="+mn-cs"/>
        </a:defRPr>
      </a:lvl4pPr>
      <a:lvl5pPr marL="2788920" algn="l" defTabSz="1394460" rtl="0" eaLnBrk="1" latinLnBrk="0" hangingPunct="1">
        <a:defRPr sz="2745" kern="1200">
          <a:solidFill>
            <a:schemeClr val="tx1"/>
          </a:solidFill>
          <a:latin typeface="+mn-lt"/>
          <a:ea typeface="+mn-ea"/>
          <a:cs typeface="+mn-cs"/>
        </a:defRPr>
      </a:lvl5pPr>
      <a:lvl6pPr marL="3486150" algn="l" defTabSz="1394460" rtl="0" eaLnBrk="1" latinLnBrk="0" hangingPunct="1">
        <a:defRPr sz="2745" kern="1200">
          <a:solidFill>
            <a:schemeClr val="tx1"/>
          </a:solidFill>
          <a:latin typeface="+mn-lt"/>
          <a:ea typeface="+mn-ea"/>
          <a:cs typeface="+mn-cs"/>
        </a:defRPr>
      </a:lvl6pPr>
      <a:lvl7pPr marL="4183380" algn="l" defTabSz="1394460" rtl="0" eaLnBrk="1" latinLnBrk="0" hangingPunct="1">
        <a:defRPr sz="2745" kern="1200">
          <a:solidFill>
            <a:schemeClr val="tx1"/>
          </a:solidFill>
          <a:latin typeface="+mn-lt"/>
          <a:ea typeface="+mn-ea"/>
          <a:cs typeface="+mn-cs"/>
        </a:defRPr>
      </a:lvl7pPr>
      <a:lvl8pPr marL="4880610" algn="l" defTabSz="1394460" rtl="0" eaLnBrk="1" latinLnBrk="0" hangingPunct="1">
        <a:defRPr sz="2745" kern="1200">
          <a:solidFill>
            <a:schemeClr val="tx1"/>
          </a:solidFill>
          <a:latin typeface="+mn-lt"/>
          <a:ea typeface="+mn-ea"/>
          <a:cs typeface="+mn-cs"/>
        </a:defRPr>
      </a:lvl8pPr>
      <a:lvl9pPr marL="5577840" algn="l" defTabSz="1394460" rtl="0" eaLnBrk="1" latinLnBrk="0" hangingPunct="1">
        <a:defRPr sz="274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po 7">
            <a:extLst>
              <a:ext uri="{FF2B5EF4-FFF2-40B4-BE49-F238E27FC236}">
                <a16:creationId xmlns:a16="http://schemas.microsoft.com/office/drawing/2014/main" id="{7A3E02C3-D408-7679-FAC0-D120B16EE274}"/>
              </a:ext>
            </a:extLst>
          </p:cNvPr>
          <p:cNvGrpSpPr/>
          <p:nvPr/>
        </p:nvGrpSpPr>
        <p:grpSpPr>
          <a:xfrm>
            <a:off x="2654715" y="669490"/>
            <a:ext cx="11227982" cy="8696283"/>
            <a:chOff x="2654715" y="669490"/>
            <a:chExt cx="11227982" cy="8696283"/>
          </a:xfrm>
        </p:grpSpPr>
        <p:grpSp>
          <p:nvGrpSpPr>
            <p:cNvPr id="7" name="Gruppo 6">
              <a:extLst>
                <a:ext uri="{FF2B5EF4-FFF2-40B4-BE49-F238E27FC236}">
                  <a16:creationId xmlns:a16="http://schemas.microsoft.com/office/drawing/2014/main" id="{6DD7C9C2-3AB1-46FF-9B81-65D2209C6DCE}"/>
                </a:ext>
              </a:extLst>
            </p:cNvPr>
            <p:cNvGrpSpPr/>
            <p:nvPr/>
          </p:nvGrpSpPr>
          <p:grpSpPr>
            <a:xfrm>
              <a:off x="2654715" y="669490"/>
              <a:ext cx="11227982" cy="7495954"/>
              <a:chOff x="2902688" y="1754372"/>
              <a:chExt cx="11227982" cy="7495954"/>
            </a:xfrm>
          </p:grpSpPr>
          <p:sp>
            <p:nvSpPr>
              <p:cNvPr id="6" name="Rettangolo 5">
                <a:extLst>
                  <a:ext uri="{FF2B5EF4-FFF2-40B4-BE49-F238E27FC236}">
                    <a16:creationId xmlns:a16="http://schemas.microsoft.com/office/drawing/2014/main" id="{B2EFD569-9A6A-4E4A-A837-C39EB2288035}"/>
                  </a:ext>
                </a:extLst>
              </p:cNvPr>
              <p:cNvSpPr/>
              <p:nvPr/>
            </p:nvSpPr>
            <p:spPr>
              <a:xfrm>
                <a:off x="2902688" y="1754372"/>
                <a:ext cx="11227982" cy="749595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5" name="Gruppo 4">
                <a:extLst>
                  <a:ext uri="{FF2B5EF4-FFF2-40B4-BE49-F238E27FC236}">
                    <a16:creationId xmlns:a16="http://schemas.microsoft.com/office/drawing/2014/main" id="{322C0E55-7BFF-49C2-8FFA-78C2A1D3952E}"/>
                  </a:ext>
                </a:extLst>
              </p:cNvPr>
              <p:cNvGrpSpPr/>
              <p:nvPr/>
            </p:nvGrpSpPr>
            <p:grpSpPr>
              <a:xfrm>
                <a:off x="3024854" y="1871330"/>
                <a:ext cx="10910739" cy="7230741"/>
                <a:chOff x="3024854" y="1871330"/>
                <a:chExt cx="10910739" cy="7230741"/>
              </a:xfrm>
            </p:grpSpPr>
            <p:pic>
              <p:nvPicPr>
                <p:cNvPr id="2" name="Immagine 1">
                  <a:extLst>
                    <a:ext uri="{FF2B5EF4-FFF2-40B4-BE49-F238E27FC236}">
                      <a16:creationId xmlns:a16="http://schemas.microsoft.com/office/drawing/2014/main" id="{B6ED8D44-A90C-446F-8802-034ECF1A6D3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8774" t="19120" r="731" b="4440"/>
                <a:stretch/>
              </p:blipFill>
              <p:spPr>
                <a:xfrm>
                  <a:off x="3048505" y="3929180"/>
                  <a:ext cx="10887088" cy="5172891"/>
                </a:xfrm>
                <a:prstGeom prst="rect">
                  <a:avLst/>
                </a:prstGeom>
              </p:spPr>
            </p:pic>
            <p:pic>
              <p:nvPicPr>
                <p:cNvPr id="3" name="Immagine 2">
                  <a:extLst>
                    <a:ext uri="{FF2B5EF4-FFF2-40B4-BE49-F238E27FC236}">
                      <a16:creationId xmlns:a16="http://schemas.microsoft.com/office/drawing/2014/main" id="{1D6924BD-C1DE-42E4-B5D7-B6BFB0D1C2C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11002" t="27897" r="20344" b="49457"/>
                <a:stretch/>
              </p:blipFill>
              <p:spPr>
                <a:xfrm>
                  <a:off x="3024854" y="1871330"/>
                  <a:ext cx="10894569" cy="2021401"/>
                </a:xfrm>
                <a:prstGeom prst="rect">
                  <a:avLst/>
                </a:prstGeom>
              </p:spPr>
            </p:pic>
          </p:grpSp>
        </p:grpSp>
        <p:sp>
          <p:nvSpPr>
            <p:cNvPr id="4" name="CasellaDiTesto 3">
              <a:extLst>
                <a:ext uri="{FF2B5EF4-FFF2-40B4-BE49-F238E27FC236}">
                  <a16:creationId xmlns:a16="http://schemas.microsoft.com/office/drawing/2014/main" id="{C2EFF0AB-D236-C496-3EA8-4B91F7166165}"/>
                </a:ext>
              </a:extLst>
            </p:cNvPr>
            <p:cNvSpPr txBox="1"/>
            <p:nvPr/>
          </p:nvSpPr>
          <p:spPr>
            <a:xfrm>
              <a:off x="2776881" y="8165444"/>
              <a:ext cx="10910739" cy="1200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800" kern="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EGFR tandem kinase domain duplication (KDD) of exons 18-25 was detected using Archer </a:t>
              </a:r>
              <a:r>
                <a:rPr lang="en-US" sz="1800" kern="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FusionPlex</a:t>
              </a:r>
              <a:r>
                <a:rPr lang="en-US" sz="1800" kern="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Custom Panel. The bottom of the panel shows NGS pileup data with coverage in both forward (orange) and reverse (blue) reads of a cDNA sequence mapping to a combined sequence of EGFR exon 25 (3′) and 18 (5′).</a:t>
              </a:r>
              <a:endParaRPr lang="it-IT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endParaRPr>
            </a:p>
            <a:p>
              <a:endParaRPr lang="it-IT" dirty="0"/>
            </a:p>
          </p:txBody>
        </p:sp>
      </p:grpSp>
    </p:spTree>
    <p:extLst>
      <p:ext uri="{BB962C8B-B14F-4D97-AF65-F5344CB8AC3E}">
        <p14:creationId xmlns:p14="http://schemas.microsoft.com/office/powerpoint/2010/main" val="204014200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63</Words>
  <Application>Microsoft Macintosh PowerPoint</Application>
  <PresentationFormat>Personalizzato</PresentationFormat>
  <Paragraphs>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5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7" baseType="lpstr">
      <vt:lpstr>Aptos</vt:lpstr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Barresi Sabina</dc:creator>
  <cp:lastModifiedBy>Emma Rullo</cp:lastModifiedBy>
  <cp:revision>4</cp:revision>
  <dcterms:created xsi:type="dcterms:W3CDTF">2024-10-22T15:51:32Z</dcterms:created>
  <dcterms:modified xsi:type="dcterms:W3CDTF">2025-01-10T22:53:25Z</dcterms:modified>
</cp:coreProperties>
</file>